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34A4D0A-7B4F-4359-BA93-2C13BF74EDA0}" type="doc">
      <dgm:prSet loTypeId="urn:microsoft.com/office/officeart/2005/8/layout/hProcess6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5150DBBA-A014-48FD-9CA4-07146E30F64D}">
      <dgm:prSet phldrT="[Text]"/>
      <dgm:spPr/>
      <dgm:t>
        <a:bodyPr/>
        <a:lstStyle/>
        <a:p>
          <a:r>
            <a:rPr lang="en-GB" dirty="0" smtClean="0"/>
            <a:t>24 weeks</a:t>
          </a:r>
          <a:endParaRPr lang="en-GB" dirty="0"/>
        </a:p>
      </dgm:t>
    </dgm:pt>
    <dgm:pt modelId="{DA971BFC-0D7A-4DE0-BDB8-E0F9EE4474A6}" type="parTrans" cxnId="{2C0DDB8A-5159-4638-A132-4CCB2119234A}">
      <dgm:prSet/>
      <dgm:spPr/>
      <dgm:t>
        <a:bodyPr/>
        <a:lstStyle/>
        <a:p>
          <a:endParaRPr lang="en-GB"/>
        </a:p>
      </dgm:t>
    </dgm:pt>
    <dgm:pt modelId="{43A8421F-1BA2-4BC0-9E74-DC3E843731A4}" type="sibTrans" cxnId="{2C0DDB8A-5159-4638-A132-4CCB2119234A}">
      <dgm:prSet/>
      <dgm:spPr/>
      <dgm:t>
        <a:bodyPr/>
        <a:lstStyle/>
        <a:p>
          <a:endParaRPr lang="en-GB"/>
        </a:p>
      </dgm:t>
    </dgm:pt>
    <dgm:pt modelId="{31FBC1D5-391B-444B-B524-94E917D06623}">
      <dgm:prSet phldrT="[Text]"/>
      <dgm:spPr/>
      <dgm:t>
        <a:bodyPr/>
        <a:lstStyle/>
        <a:p>
          <a:r>
            <a:rPr lang="en-GB" dirty="0"/>
            <a:t>Follow up clinical </a:t>
          </a:r>
          <a:r>
            <a:rPr lang="en-GB" dirty="0" smtClean="0"/>
            <a:t>visits at 12 &amp; 24 weeks</a:t>
          </a:r>
          <a:endParaRPr lang="en-GB" dirty="0"/>
        </a:p>
      </dgm:t>
    </dgm:pt>
    <dgm:pt modelId="{7864CD3C-CE53-4E32-BD2C-4C96558ABF97}" type="parTrans" cxnId="{0B361C4D-EA01-4243-A76F-67E4D254019A}">
      <dgm:prSet/>
      <dgm:spPr/>
      <dgm:t>
        <a:bodyPr/>
        <a:lstStyle/>
        <a:p>
          <a:endParaRPr lang="en-GB"/>
        </a:p>
      </dgm:t>
    </dgm:pt>
    <dgm:pt modelId="{BB37BEB6-10FF-4092-B45C-1D58BC0E6A57}" type="sibTrans" cxnId="{0B361C4D-EA01-4243-A76F-67E4D254019A}">
      <dgm:prSet/>
      <dgm:spPr/>
      <dgm:t>
        <a:bodyPr/>
        <a:lstStyle/>
        <a:p>
          <a:endParaRPr lang="en-GB"/>
        </a:p>
      </dgm:t>
    </dgm:pt>
    <dgm:pt modelId="{7E15A40E-EB63-4F19-9FB6-8BC8EAB63B7A}">
      <dgm:prSet phldrT="[Text]"/>
      <dgm:spPr/>
      <dgm:t>
        <a:bodyPr/>
        <a:lstStyle/>
        <a:p>
          <a:endParaRPr lang="en-GB" dirty="0"/>
        </a:p>
      </dgm:t>
    </dgm:pt>
    <dgm:pt modelId="{E773C87C-F0B9-4922-85D5-B701A31C0C8A}" type="parTrans" cxnId="{31064EF3-6143-4BA2-846C-E31A1E126CEB}">
      <dgm:prSet/>
      <dgm:spPr/>
      <dgm:t>
        <a:bodyPr/>
        <a:lstStyle/>
        <a:p>
          <a:endParaRPr lang="en-GB"/>
        </a:p>
      </dgm:t>
    </dgm:pt>
    <dgm:pt modelId="{EA7471FC-5D26-49CE-95D8-A567D819342F}" type="sibTrans" cxnId="{31064EF3-6143-4BA2-846C-E31A1E126CEB}">
      <dgm:prSet/>
      <dgm:spPr/>
      <dgm:t>
        <a:bodyPr/>
        <a:lstStyle/>
        <a:p>
          <a:endParaRPr lang="en-GB"/>
        </a:p>
      </dgm:t>
    </dgm:pt>
    <dgm:pt modelId="{2E4CFC3E-1DC3-431E-9CD7-BE4BF56F5B26}">
      <dgm:prSet phldrT="[Text]"/>
      <dgm:spPr/>
      <dgm:t>
        <a:bodyPr/>
        <a:lstStyle/>
        <a:p>
          <a:endParaRPr lang="en-GB" dirty="0"/>
        </a:p>
      </dgm:t>
    </dgm:pt>
    <dgm:pt modelId="{A7DC3164-4424-48CC-A256-72614D95F963}" type="parTrans" cxnId="{58E4C5E2-84B6-4D91-A7F2-5C2258225E12}">
      <dgm:prSet/>
      <dgm:spPr/>
      <dgm:t>
        <a:bodyPr/>
        <a:lstStyle/>
        <a:p>
          <a:endParaRPr lang="en-US"/>
        </a:p>
      </dgm:t>
    </dgm:pt>
    <dgm:pt modelId="{C58881F9-02A4-4A2D-924A-BEF1361E5DCA}" type="sibTrans" cxnId="{58E4C5E2-84B6-4D91-A7F2-5C2258225E12}">
      <dgm:prSet/>
      <dgm:spPr/>
      <dgm:t>
        <a:bodyPr/>
        <a:lstStyle/>
        <a:p>
          <a:endParaRPr lang="en-US"/>
        </a:p>
      </dgm:t>
    </dgm:pt>
    <dgm:pt modelId="{184825D8-C33A-42BC-9F24-523D837473BC}">
      <dgm:prSet phldrT="[Text]"/>
      <dgm:spPr/>
      <dgm:t>
        <a:bodyPr/>
        <a:lstStyle/>
        <a:p>
          <a:r>
            <a:rPr lang="en-GB" dirty="0" smtClean="0"/>
            <a:t>12 week Cholesterol </a:t>
          </a:r>
          <a:r>
            <a:rPr lang="en-GB" dirty="0" err="1" smtClean="0"/>
            <a:t>CarePlan</a:t>
          </a:r>
          <a:r>
            <a:rPr lang="en-GB" dirty="0" smtClean="0"/>
            <a:t> ?s</a:t>
          </a:r>
          <a:endParaRPr lang="en-GB" dirty="0"/>
        </a:p>
      </dgm:t>
    </dgm:pt>
    <dgm:pt modelId="{A00667A2-E3A9-4F29-98DC-B4C6289D1B14}" type="parTrans" cxnId="{33625907-CA49-4E24-95B5-368457921810}">
      <dgm:prSet/>
      <dgm:spPr/>
      <dgm:t>
        <a:bodyPr/>
        <a:lstStyle/>
        <a:p>
          <a:endParaRPr lang="en-US"/>
        </a:p>
      </dgm:t>
    </dgm:pt>
    <dgm:pt modelId="{A75D5347-D9C8-4224-A439-5DC9D23D3AD3}" type="sibTrans" cxnId="{33625907-CA49-4E24-95B5-368457921810}">
      <dgm:prSet/>
      <dgm:spPr/>
      <dgm:t>
        <a:bodyPr/>
        <a:lstStyle/>
        <a:p>
          <a:endParaRPr lang="en-US"/>
        </a:p>
      </dgm:t>
    </dgm:pt>
    <dgm:pt modelId="{B20DE993-EC76-4012-921D-37ACF96121B2}">
      <dgm:prSet phldrT="[Text]"/>
      <dgm:spPr/>
      <dgm:t>
        <a:bodyPr/>
        <a:lstStyle/>
        <a:p>
          <a:r>
            <a:rPr lang="en-GB" dirty="0" smtClean="0"/>
            <a:t>Baseline clinical </a:t>
          </a:r>
          <a:r>
            <a:rPr lang="en-GB" dirty="0"/>
            <a:t>visit</a:t>
          </a:r>
        </a:p>
      </dgm:t>
    </dgm:pt>
    <dgm:pt modelId="{13E580C5-B282-40FF-A8D6-DEB9A487222B}" type="sibTrans" cxnId="{52285C53-D490-4476-BDFC-825228EDAA2F}">
      <dgm:prSet/>
      <dgm:spPr/>
      <dgm:t>
        <a:bodyPr/>
        <a:lstStyle/>
        <a:p>
          <a:endParaRPr lang="en-GB"/>
        </a:p>
      </dgm:t>
    </dgm:pt>
    <dgm:pt modelId="{840D9F93-76D3-4E61-A557-A3FC019B4CFC}" type="parTrans" cxnId="{52285C53-D490-4476-BDFC-825228EDAA2F}">
      <dgm:prSet/>
      <dgm:spPr/>
      <dgm:t>
        <a:bodyPr/>
        <a:lstStyle/>
        <a:p>
          <a:endParaRPr lang="en-GB"/>
        </a:p>
      </dgm:t>
    </dgm:pt>
    <dgm:pt modelId="{07DE7DBE-459C-488B-921C-1798FD60EA0B}">
      <dgm:prSet/>
      <dgm:spPr/>
      <dgm:t>
        <a:bodyPr/>
        <a:lstStyle/>
        <a:p>
          <a:endParaRPr lang="en-GB" dirty="0"/>
        </a:p>
      </dgm:t>
    </dgm:pt>
    <dgm:pt modelId="{382AB4E6-9B94-47B8-88F7-7FB05D9E6319}" type="sibTrans" cxnId="{14C7BF01-B892-4601-A2C9-91EC9FB33D37}">
      <dgm:prSet/>
      <dgm:spPr/>
      <dgm:t>
        <a:bodyPr/>
        <a:lstStyle/>
        <a:p>
          <a:endParaRPr lang="en-GB"/>
        </a:p>
      </dgm:t>
    </dgm:pt>
    <dgm:pt modelId="{B1C441C3-C458-41F7-AC39-47F9F3054A17}" type="parTrans" cxnId="{14C7BF01-B892-4601-A2C9-91EC9FB33D37}">
      <dgm:prSet/>
      <dgm:spPr/>
      <dgm:t>
        <a:bodyPr/>
        <a:lstStyle/>
        <a:p>
          <a:endParaRPr lang="en-GB"/>
        </a:p>
      </dgm:t>
    </dgm:pt>
    <dgm:pt modelId="{39955DF2-2E4B-45FB-ADC2-5CAF6E5F4AB0}">
      <dgm:prSet/>
      <dgm:spPr/>
      <dgm:t>
        <a:bodyPr/>
        <a:lstStyle/>
        <a:p>
          <a:endParaRPr lang="en-GB" dirty="0"/>
        </a:p>
      </dgm:t>
    </dgm:pt>
    <dgm:pt modelId="{C88461C2-401D-4217-866A-99764488615D}" type="sibTrans" cxnId="{93A8FA1D-5D79-4ED6-AD8E-43ADB8893D4B}">
      <dgm:prSet/>
      <dgm:spPr/>
      <dgm:t>
        <a:bodyPr/>
        <a:lstStyle/>
        <a:p>
          <a:endParaRPr lang="en-GB"/>
        </a:p>
      </dgm:t>
    </dgm:pt>
    <dgm:pt modelId="{B22DEC13-D4A3-43AC-A48D-BB57EF54B77B}" type="parTrans" cxnId="{93A8FA1D-5D79-4ED6-AD8E-43ADB8893D4B}">
      <dgm:prSet/>
      <dgm:spPr/>
      <dgm:t>
        <a:bodyPr/>
        <a:lstStyle/>
        <a:p>
          <a:endParaRPr lang="en-GB"/>
        </a:p>
      </dgm:t>
    </dgm:pt>
    <dgm:pt modelId="{FC8AE758-2B09-4196-8FE9-6F67F6BD2C2D}">
      <dgm:prSet/>
      <dgm:spPr/>
      <dgm:t>
        <a:bodyPr/>
        <a:lstStyle/>
        <a:p>
          <a:r>
            <a:rPr lang="en-GB" dirty="0" smtClean="0"/>
            <a:t>Cholesterol</a:t>
          </a:r>
          <a:endParaRPr lang="en-GB" dirty="0"/>
        </a:p>
      </dgm:t>
    </dgm:pt>
    <dgm:pt modelId="{CF129698-BF79-4BED-BAF0-32E041BAAFBB}" type="sibTrans" cxnId="{9E493F2B-9610-41AA-8105-588783599362}">
      <dgm:prSet/>
      <dgm:spPr/>
      <dgm:t>
        <a:bodyPr/>
        <a:lstStyle/>
        <a:p>
          <a:endParaRPr lang="en-GB"/>
        </a:p>
      </dgm:t>
    </dgm:pt>
    <dgm:pt modelId="{2CAC8BBC-3753-4D45-9B63-E42E51C4A9AE}" type="parTrans" cxnId="{9E493F2B-9610-41AA-8105-588783599362}">
      <dgm:prSet/>
      <dgm:spPr/>
      <dgm:t>
        <a:bodyPr/>
        <a:lstStyle/>
        <a:p>
          <a:endParaRPr lang="en-GB"/>
        </a:p>
      </dgm:t>
    </dgm:pt>
    <dgm:pt modelId="{1918FBF4-E643-4F52-92A3-95107699BE21}">
      <dgm:prSet/>
      <dgm:spPr/>
      <dgm:t>
        <a:bodyPr/>
        <a:lstStyle/>
        <a:p>
          <a:r>
            <a:rPr lang="en-GB" dirty="0" smtClean="0"/>
            <a:t>Smoking</a:t>
          </a:r>
          <a:endParaRPr lang="en-GB" dirty="0"/>
        </a:p>
      </dgm:t>
    </dgm:pt>
    <dgm:pt modelId="{EE8BB1CD-A87B-493D-A76E-230B0391702B}" type="sibTrans" cxnId="{03693CC0-4C0C-48F3-B2CF-166E055BF018}">
      <dgm:prSet/>
      <dgm:spPr/>
      <dgm:t>
        <a:bodyPr/>
        <a:lstStyle/>
        <a:p>
          <a:endParaRPr lang="en-US"/>
        </a:p>
      </dgm:t>
    </dgm:pt>
    <dgm:pt modelId="{C5A08192-E9EF-42BF-9B89-D96BA339ACEB}" type="parTrans" cxnId="{03693CC0-4C0C-48F3-B2CF-166E055BF018}">
      <dgm:prSet/>
      <dgm:spPr/>
      <dgm:t>
        <a:bodyPr/>
        <a:lstStyle/>
        <a:p>
          <a:endParaRPr lang="en-US"/>
        </a:p>
      </dgm:t>
    </dgm:pt>
    <dgm:pt modelId="{049B07E6-379F-4F93-AAC4-B0B26BC5400D}">
      <dgm:prSet/>
      <dgm:spPr/>
      <dgm:t>
        <a:bodyPr/>
        <a:lstStyle/>
        <a:p>
          <a:r>
            <a:rPr lang="en-GB" dirty="0" smtClean="0"/>
            <a:t>Weight</a:t>
          </a:r>
          <a:endParaRPr lang="en-GB" dirty="0"/>
        </a:p>
      </dgm:t>
    </dgm:pt>
    <dgm:pt modelId="{B1469DC8-BC17-45FF-9EC1-2641FA1A37E8}" type="sibTrans" cxnId="{389245B5-9E6A-4219-81B9-A7F05015889F}">
      <dgm:prSet/>
      <dgm:spPr/>
      <dgm:t>
        <a:bodyPr/>
        <a:lstStyle/>
        <a:p>
          <a:endParaRPr lang="en-GB"/>
        </a:p>
      </dgm:t>
    </dgm:pt>
    <dgm:pt modelId="{3BDA9A0F-164E-4D04-B6ED-C738B0C2D474}" type="parTrans" cxnId="{389245B5-9E6A-4219-81B9-A7F05015889F}">
      <dgm:prSet/>
      <dgm:spPr/>
      <dgm:t>
        <a:bodyPr/>
        <a:lstStyle/>
        <a:p>
          <a:endParaRPr lang="en-GB"/>
        </a:p>
      </dgm:t>
    </dgm:pt>
    <dgm:pt modelId="{BE0C1D85-AAFF-420D-BC87-DFFC975AD54E}">
      <dgm:prSet/>
      <dgm:spPr/>
      <dgm:t>
        <a:bodyPr/>
        <a:lstStyle/>
        <a:p>
          <a:r>
            <a:rPr lang="en-GB" dirty="0" smtClean="0"/>
            <a:t>Height</a:t>
          </a:r>
          <a:endParaRPr lang="en-GB" dirty="0"/>
        </a:p>
      </dgm:t>
    </dgm:pt>
    <dgm:pt modelId="{BB49430A-9D19-4C13-8854-5C1A4D9A7CCD}" type="sibTrans" cxnId="{3B32DFCF-E29F-4938-862D-F5563BDAFAD0}">
      <dgm:prSet/>
      <dgm:spPr/>
      <dgm:t>
        <a:bodyPr/>
        <a:lstStyle/>
        <a:p>
          <a:endParaRPr lang="en-US"/>
        </a:p>
      </dgm:t>
    </dgm:pt>
    <dgm:pt modelId="{C7EAF8A6-3E2B-4BAD-82E1-820E02717236}" type="parTrans" cxnId="{3B32DFCF-E29F-4938-862D-F5563BDAFAD0}">
      <dgm:prSet/>
      <dgm:spPr/>
      <dgm:t>
        <a:bodyPr/>
        <a:lstStyle/>
        <a:p>
          <a:endParaRPr lang="en-US"/>
        </a:p>
      </dgm:t>
    </dgm:pt>
    <dgm:pt modelId="{60107EE6-0C11-4821-B119-F7EC064CF1DC}">
      <dgm:prSet/>
      <dgm:spPr/>
      <dgm:t>
        <a:bodyPr/>
        <a:lstStyle/>
        <a:p>
          <a:r>
            <a:rPr lang="en-GB" dirty="0" smtClean="0"/>
            <a:t>Blood pressure</a:t>
          </a:r>
          <a:endParaRPr lang="en-GB" dirty="0"/>
        </a:p>
      </dgm:t>
    </dgm:pt>
    <dgm:pt modelId="{38E7ED07-67BF-4AAF-BB68-0D05C78492B0}" type="parTrans" cxnId="{315BFF21-71D8-4187-8B6B-24E753398151}">
      <dgm:prSet/>
      <dgm:spPr/>
      <dgm:t>
        <a:bodyPr/>
        <a:lstStyle/>
        <a:p>
          <a:endParaRPr lang="en-US"/>
        </a:p>
      </dgm:t>
    </dgm:pt>
    <dgm:pt modelId="{32257F5C-F54E-4462-9767-E9846C0A0B50}" type="sibTrans" cxnId="{315BFF21-71D8-4187-8B6B-24E753398151}">
      <dgm:prSet/>
      <dgm:spPr/>
      <dgm:t>
        <a:bodyPr/>
        <a:lstStyle/>
        <a:p>
          <a:endParaRPr lang="en-US"/>
        </a:p>
      </dgm:t>
    </dgm:pt>
    <dgm:pt modelId="{6D276FF8-10B7-4311-AEEA-3660129A06FD}">
      <dgm:prSet/>
      <dgm:spPr/>
      <dgm:t>
        <a:bodyPr/>
        <a:lstStyle/>
        <a:p>
          <a:r>
            <a:rPr lang="en-GB" dirty="0" smtClean="0"/>
            <a:t>Web app ?s on Socio-Demographics and Medication Adherence</a:t>
          </a:r>
          <a:endParaRPr lang="en-GB" dirty="0"/>
        </a:p>
      </dgm:t>
    </dgm:pt>
    <dgm:pt modelId="{51891255-A27E-4B4B-94ED-F9BA41CEF62E}" type="parTrans" cxnId="{255EFC92-C096-4371-A3DF-8BEF77452F07}">
      <dgm:prSet/>
      <dgm:spPr/>
      <dgm:t>
        <a:bodyPr/>
        <a:lstStyle/>
        <a:p>
          <a:endParaRPr lang="en-US"/>
        </a:p>
      </dgm:t>
    </dgm:pt>
    <dgm:pt modelId="{B9B61D9E-9F60-4FA5-B417-AA6DF1371E9B}" type="sibTrans" cxnId="{255EFC92-C096-4371-A3DF-8BEF77452F07}">
      <dgm:prSet/>
      <dgm:spPr/>
      <dgm:t>
        <a:bodyPr/>
        <a:lstStyle/>
        <a:p>
          <a:endParaRPr lang="en-US"/>
        </a:p>
      </dgm:t>
    </dgm:pt>
    <dgm:pt modelId="{57F6C132-9116-47D5-B649-218BFE557B40}">
      <dgm:prSet phldrT="[Text]"/>
      <dgm:spPr/>
      <dgm:t>
        <a:bodyPr/>
        <a:lstStyle/>
        <a:p>
          <a:r>
            <a:rPr lang="en-GB" dirty="0" smtClean="0"/>
            <a:t>Cholesterol</a:t>
          </a:r>
          <a:endParaRPr lang="en-GB" dirty="0"/>
        </a:p>
      </dgm:t>
    </dgm:pt>
    <dgm:pt modelId="{58C7C361-799C-4E35-B0AD-6307CD23FA27}" type="sibTrans" cxnId="{38A10E6E-4538-4E10-8500-0B21A31E76C6}">
      <dgm:prSet/>
      <dgm:spPr/>
      <dgm:t>
        <a:bodyPr/>
        <a:lstStyle/>
        <a:p>
          <a:endParaRPr lang="en-GB"/>
        </a:p>
      </dgm:t>
    </dgm:pt>
    <dgm:pt modelId="{1713CB1F-2096-465B-BAC3-62CF4F341950}" type="parTrans" cxnId="{38A10E6E-4538-4E10-8500-0B21A31E76C6}">
      <dgm:prSet/>
      <dgm:spPr/>
      <dgm:t>
        <a:bodyPr/>
        <a:lstStyle/>
        <a:p>
          <a:endParaRPr lang="en-GB"/>
        </a:p>
      </dgm:t>
    </dgm:pt>
    <dgm:pt modelId="{1A48361F-612E-432D-B787-BC4DBDD6D90A}">
      <dgm:prSet/>
      <dgm:spPr/>
      <dgm:t>
        <a:bodyPr/>
        <a:lstStyle/>
        <a:p>
          <a:r>
            <a:rPr lang="en-GB" smtClean="0"/>
            <a:t>Blood pressure</a:t>
          </a:r>
          <a:endParaRPr lang="en-GB" dirty="0"/>
        </a:p>
      </dgm:t>
    </dgm:pt>
    <dgm:pt modelId="{BF6A5259-EFEE-40C6-8C6A-5601D6D7F141}" type="parTrans" cxnId="{870B2170-CE12-4E32-9557-D0973EE25F1B}">
      <dgm:prSet/>
      <dgm:spPr/>
      <dgm:t>
        <a:bodyPr/>
        <a:lstStyle/>
        <a:p>
          <a:endParaRPr lang="en-US"/>
        </a:p>
      </dgm:t>
    </dgm:pt>
    <dgm:pt modelId="{68916E09-41D1-4577-B018-6A34DAEDBE87}" type="sibTrans" cxnId="{870B2170-CE12-4E32-9557-D0973EE25F1B}">
      <dgm:prSet/>
      <dgm:spPr/>
      <dgm:t>
        <a:bodyPr/>
        <a:lstStyle/>
        <a:p>
          <a:endParaRPr lang="en-US"/>
        </a:p>
      </dgm:t>
    </dgm:pt>
    <dgm:pt modelId="{C757DCC9-0426-4524-8BD3-A20BA0C5C54C}">
      <dgm:prSet/>
      <dgm:spPr/>
      <dgm:t>
        <a:bodyPr/>
        <a:lstStyle/>
        <a:p>
          <a:r>
            <a:rPr lang="en-GB" dirty="0" smtClean="0"/>
            <a:t>Smoking</a:t>
          </a:r>
          <a:endParaRPr lang="en-GB" dirty="0"/>
        </a:p>
      </dgm:t>
    </dgm:pt>
    <dgm:pt modelId="{E768FE76-1FDD-4353-BE0D-23C80A963D59}" type="parTrans" cxnId="{B45C8431-F422-42AE-A48C-8C74AD22D5A9}">
      <dgm:prSet/>
      <dgm:spPr/>
      <dgm:t>
        <a:bodyPr/>
        <a:lstStyle/>
        <a:p>
          <a:endParaRPr lang="en-US"/>
        </a:p>
      </dgm:t>
    </dgm:pt>
    <dgm:pt modelId="{BEDB578A-015E-4632-8AB8-63F1B1AECAD8}" type="sibTrans" cxnId="{B45C8431-F422-42AE-A48C-8C74AD22D5A9}">
      <dgm:prSet/>
      <dgm:spPr/>
      <dgm:t>
        <a:bodyPr/>
        <a:lstStyle/>
        <a:p>
          <a:endParaRPr lang="en-US"/>
        </a:p>
      </dgm:t>
    </dgm:pt>
    <dgm:pt modelId="{639ED891-5B28-4B29-96A9-A01F716C6E30}">
      <dgm:prSet/>
      <dgm:spPr/>
      <dgm:t>
        <a:bodyPr/>
        <a:lstStyle/>
        <a:p>
          <a:r>
            <a:rPr lang="en-GB" dirty="0" smtClean="0"/>
            <a:t>Weight</a:t>
          </a:r>
          <a:endParaRPr lang="en-US" dirty="0"/>
        </a:p>
      </dgm:t>
    </dgm:pt>
    <dgm:pt modelId="{487B522A-10CD-49F6-9DF9-19CC13EF4DA4}" type="parTrans" cxnId="{1A5D7740-3AAD-4482-A04A-6AB0B5E690CD}">
      <dgm:prSet/>
      <dgm:spPr/>
      <dgm:t>
        <a:bodyPr/>
        <a:lstStyle/>
        <a:p>
          <a:endParaRPr lang="en-US"/>
        </a:p>
      </dgm:t>
    </dgm:pt>
    <dgm:pt modelId="{E3D15A27-84A7-4744-901F-D09004205918}" type="sibTrans" cxnId="{1A5D7740-3AAD-4482-A04A-6AB0B5E690CD}">
      <dgm:prSet/>
      <dgm:spPr/>
      <dgm:t>
        <a:bodyPr/>
        <a:lstStyle/>
        <a:p>
          <a:endParaRPr lang="en-US"/>
        </a:p>
      </dgm:t>
    </dgm:pt>
    <dgm:pt modelId="{E682EC61-8460-43B8-B0F7-1CFBADF7C09A}">
      <dgm:prSet/>
      <dgm:spPr/>
      <dgm:t>
        <a:bodyPr/>
        <a:lstStyle/>
        <a:p>
          <a:r>
            <a:rPr lang="en-GB" dirty="0" smtClean="0"/>
            <a:t>Web app ?s on Medication Adherence</a:t>
          </a:r>
          <a:endParaRPr lang="en-US" dirty="0"/>
        </a:p>
      </dgm:t>
    </dgm:pt>
    <dgm:pt modelId="{47BB6492-DF80-489D-9360-A371BB487629}" type="parTrans" cxnId="{3FB809BD-4872-4A66-BF24-C4E37C57CF1E}">
      <dgm:prSet/>
      <dgm:spPr/>
      <dgm:t>
        <a:bodyPr/>
        <a:lstStyle/>
        <a:p>
          <a:endParaRPr lang="en-US"/>
        </a:p>
      </dgm:t>
    </dgm:pt>
    <dgm:pt modelId="{6C57644B-2EAE-4579-B72B-27E7FCBF3BF0}" type="sibTrans" cxnId="{3FB809BD-4872-4A66-BF24-C4E37C57CF1E}">
      <dgm:prSet/>
      <dgm:spPr/>
      <dgm:t>
        <a:bodyPr/>
        <a:lstStyle/>
        <a:p>
          <a:endParaRPr lang="en-US"/>
        </a:p>
      </dgm:t>
    </dgm:pt>
    <dgm:pt modelId="{A02AE9FF-C39D-4772-9F88-A01CF160D324}">
      <dgm:prSet phldrT="[Text]"/>
      <dgm:spPr/>
      <dgm:t>
        <a:bodyPr/>
        <a:lstStyle/>
        <a:p>
          <a:r>
            <a:rPr lang="en-GB" smtClean="0"/>
            <a:t>Additional </a:t>
          </a:r>
          <a:r>
            <a:rPr lang="en-GB" smtClean="0"/>
            <a:t>Web </a:t>
          </a:r>
          <a:r>
            <a:rPr lang="en-GB" dirty="0" smtClean="0"/>
            <a:t>app ?s at weeks 1, 6, 12 &amp; 24.</a:t>
          </a:r>
          <a:endParaRPr lang="en-GB" dirty="0"/>
        </a:p>
      </dgm:t>
    </dgm:pt>
    <dgm:pt modelId="{9E19E5C4-913C-401A-9346-85454391A7B6}" type="parTrans" cxnId="{D59C1AFA-7800-46AB-A478-A94120702388}">
      <dgm:prSet/>
      <dgm:spPr/>
      <dgm:t>
        <a:bodyPr/>
        <a:lstStyle/>
        <a:p>
          <a:endParaRPr lang="en-US"/>
        </a:p>
      </dgm:t>
    </dgm:pt>
    <dgm:pt modelId="{394C0E86-001C-46AD-A45C-8F85901AF628}" type="sibTrans" cxnId="{D59C1AFA-7800-46AB-A478-A94120702388}">
      <dgm:prSet/>
      <dgm:spPr/>
      <dgm:t>
        <a:bodyPr/>
        <a:lstStyle/>
        <a:p>
          <a:endParaRPr lang="en-US"/>
        </a:p>
      </dgm:t>
    </dgm:pt>
    <dgm:pt modelId="{DDB4539C-42BD-483C-B354-AD3972DB1830}" type="pres">
      <dgm:prSet presAssocID="{834A4D0A-7B4F-4359-BA93-2C13BF74EDA0}" presName="theList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D2196A4D-F295-4B49-B2D3-7B36ADB1D0C8}" type="pres">
      <dgm:prSet presAssocID="{B20DE993-EC76-4012-921D-37ACF96121B2}" presName="compNode" presStyleCnt="0"/>
      <dgm:spPr/>
    </dgm:pt>
    <dgm:pt modelId="{D4DEFC61-50E1-4863-810B-725548DCAEF1}" type="pres">
      <dgm:prSet presAssocID="{B20DE993-EC76-4012-921D-37ACF96121B2}" presName="noGeometry" presStyleCnt="0"/>
      <dgm:spPr/>
    </dgm:pt>
    <dgm:pt modelId="{FD5FE5AF-D80B-4FBB-9606-C1B3398D8AC2}" type="pres">
      <dgm:prSet presAssocID="{B20DE993-EC76-4012-921D-37ACF96121B2}" presName="childTextVisible" presStyleLbl="bgAccFollowNode1" presStyleIdx="0" presStyleCnt="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674AF7A1-B4E1-45FE-8271-D9779195F5D9}" type="pres">
      <dgm:prSet presAssocID="{B20DE993-EC76-4012-921D-37ACF96121B2}" presName="childTextHidden" presStyleLbl="bgAccFollowNode1" presStyleIdx="0" presStyleCnt="3"/>
      <dgm:spPr/>
      <dgm:t>
        <a:bodyPr/>
        <a:lstStyle/>
        <a:p>
          <a:endParaRPr lang="en-GB"/>
        </a:p>
      </dgm:t>
    </dgm:pt>
    <dgm:pt modelId="{AE8C43CD-72A9-4611-AAA1-7A65254F2684}" type="pres">
      <dgm:prSet presAssocID="{B20DE993-EC76-4012-921D-37ACF96121B2}" presName="parentText" presStyleLbl="node1" presStyleIdx="0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2582866-5DCA-496D-9BCF-C16385E842E5}" type="pres">
      <dgm:prSet presAssocID="{B20DE993-EC76-4012-921D-37ACF96121B2}" presName="aSpace" presStyleCnt="0"/>
      <dgm:spPr/>
    </dgm:pt>
    <dgm:pt modelId="{59E6896B-4A7C-4074-857B-45A9D4F0F68A}" type="pres">
      <dgm:prSet presAssocID="{5150DBBA-A014-48FD-9CA4-07146E30F64D}" presName="compNode" presStyleCnt="0"/>
      <dgm:spPr/>
    </dgm:pt>
    <dgm:pt modelId="{08FA1EAD-C649-432A-8CA4-5A04CA1B0426}" type="pres">
      <dgm:prSet presAssocID="{5150DBBA-A014-48FD-9CA4-07146E30F64D}" presName="noGeometry" presStyleCnt="0"/>
      <dgm:spPr/>
    </dgm:pt>
    <dgm:pt modelId="{DB921617-3D76-43EA-9080-A6928D957AC0}" type="pres">
      <dgm:prSet presAssocID="{5150DBBA-A014-48FD-9CA4-07146E30F64D}" presName="childTextVisible" presStyleLbl="bgAccFollowNode1" presStyleIdx="1" presStyleCnt="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D50B4D5-67A0-4F7B-8A36-7FED3A0BADCD}" type="pres">
      <dgm:prSet presAssocID="{5150DBBA-A014-48FD-9CA4-07146E30F64D}" presName="childTextHidden" presStyleLbl="bgAccFollowNode1" presStyleIdx="1" presStyleCnt="3"/>
      <dgm:spPr/>
      <dgm:t>
        <a:bodyPr/>
        <a:lstStyle/>
        <a:p>
          <a:endParaRPr lang="en-GB"/>
        </a:p>
      </dgm:t>
    </dgm:pt>
    <dgm:pt modelId="{DB9C4CDC-829A-4D3A-836C-CB22248CED44}" type="pres">
      <dgm:prSet presAssocID="{5150DBBA-A014-48FD-9CA4-07146E30F64D}" presName="parentText" presStyleLbl="node1" presStyleIdx="1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33C1EFC-4304-4BE8-9838-50B03682242F}" type="pres">
      <dgm:prSet presAssocID="{5150DBBA-A014-48FD-9CA4-07146E30F64D}" presName="aSpace" presStyleCnt="0"/>
      <dgm:spPr/>
    </dgm:pt>
    <dgm:pt modelId="{10A02346-F88F-43BF-89F9-F2E597165644}" type="pres">
      <dgm:prSet presAssocID="{31FBC1D5-391B-444B-B524-94E917D06623}" presName="compNode" presStyleCnt="0"/>
      <dgm:spPr/>
    </dgm:pt>
    <dgm:pt modelId="{FC1DD737-B969-4F9D-9752-AA1BCF340654}" type="pres">
      <dgm:prSet presAssocID="{31FBC1D5-391B-444B-B524-94E917D06623}" presName="noGeometry" presStyleCnt="0"/>
      <dgm:spPr/>
    </dgm:pt>
    <dgm:pt modelId="{AAAB698C-F27B-44AE-89C0-200949C3E0BF}" type="pres">
      <dgm:prSet presAssocID="{31FBC1D5-391B-444B-B524-94E917D06623}" presName="childTextVisible" presStyleLbl="bgAccFollowNode1" presStyleIdx="2" presStyleCnt="3" custLinFactNeighborX="189" custLinFactNeighborY="-85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F3692B1-8F48-42C6-85DF-6227852D481E}" type="pres">
      <dgm:prSet presAssocID="{31FBC1D5-391B-444B-B524-94E917D06623}" presName="childTextHidden" presStyleLbl="bgAccFollowNode1" presStyleIdx="2" presStyleCnt="3"/>
      <dgm:spPr/>
      <dgm:t>
        <a:bodyPr/>
        <a:lstStyle/>
        <a:p>
          <a:endParaRPr lang="en-GB"/>
        </a:p>
      </dgm:t>
    </dgm:pt>
    <dgm:pt modelId="{651066C6-62ED-4D8C-AE28-B19E8DDBBC20}" type="pres">
      <dgm:prSet presAssocID="{31FBC1D5-391B-444B-B524-94E917D06623}" presName="parentText" presStyleLbl="node1" presStyleIdx="2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7CB50392-9A10-42BD-8FF5-DF3AE30F6FD8}" type="presOf" srcId="{57F6C132-9116-47D5-B649-218BFE557B40}" destId="{9F3692B1-8F48-42C6-85DF-6227852D481E}" srcOrd="1" destOrd="1" presId="urn:microsoft.com/office/officeart/2005/8/layout/hProcess6"/>
    <dgm:cxn modelId="{11F561DF-0F67-4391-A34A-16D7B43952CB}" type="presOf" srcId="{C757DCC9-0426-4524-8BD3-A20BA0C5C54C}" destId="{AAAB698C-F27B-44AE-89C0-200949C3E0BF}" srcOrd="0" destOrd="3" presId="urn:microsoft.com/office/officeart/2005/8/layout/hProcess6"/>
    <dgm:cxn modelId="{870B2170-CE12-4E32-9557-D0973EE25F1B}" srcId="{31FBC1D5-391B-444B-B524-94E917D06623}" destId="{1A48361F-612E-432D-B787-BC4DBDD6D90A}" srcOrd="2" destOrd="0" parTransId="{BF6A5259-EFEE-40C6-8C6A-5601D6D7F141}" sibTransId="{68916E09-41D1-4577-B018-6A34DAEDBE87}"/>
    <dgm:cxn modelId="{22F20D1B-9096-4598-83AD-7A77805B433B}" type="presOf" srcId="{C757DCC9-0426-4524-8BD3-A20BA0C5C54C}" destId="{9F3692B1-8F48-42C6-85DF-6227852D481E}" srcOrd="1" destOrd="3" presId="urn:microsoft.com/office/officeart/2005/8/layout/hProcess6"/>
    <dgm:cxn modelId="{FEDB3CB3-A271-4169-810D-8BADDE1329B3}" type="presOf" srcId="{31FBC1D5-391B-444B-B524-94E917D06623}" destId="{651066C6-62ED-4D8C-AE28-B19E8DDBBC20}" srcOrd="0" destOrd="0" presId="urn:microsoft.com/office/officeart/2005/8/layout/hProcess6"/>
    <dgm:cxn modelId="{33625907-CA49-4E24-95B5-368457921810}" srcId="{5150DBBA-A014-48FD-9CA4-07146E30F64D}" destId="{184825D8-C33A-42BC-9F24-523D837473BC}" srcOrd="1" destOrd="0" parTransId="{A00667A2-E3A9-4F29-98DC-B4C6289D1B14}" sibTransId="{A75D5347-D9C8-4224-A439-5DC9D23D3AD3}"/>
    <dgm:cxn modelId="{B45C8431-F422-42AE-A48C-8C74AD22D5A9}" srcId="{31FBC1D5-391B-444B-B524-94E917D06623}" destId="{C757DCC9-0426-4524-8BD3-A20BA0C5C54C}" srcOrd="3" destOrd="0" parTransId="{E768FE76-1FDD-4353-BE0D-23C80A963D59}" sibTransId="{BEDB578A-015E-4632-8AB8-63F1B1AECAD8}"/>
    <dgm:cxn modelId="{26C71253-1D7E-4545-B3BA-D8361FB5E636}" type="presOf" srcId="{7E15A40E-EB63-4F19-9FB6-8BC8EAB63B7A}" destId="{AAAB698C-F27B-44AE-89C0-200949C3E0BF}" srcOrd="0" destOrd="0" presId="urn:microsoft.com/office/officeart/2005/8/layout/hProcess6"/>
    <dgm:cxn modelId="{C0FE3EB1-DC70-4604-90E7-94AF85E971A0}" type="presOf" srcId="{B20DE993-EC76-4012-921D-37ACF96121B2}" destId="{AE8C43CD-72A9-4611-AAA1-7A65254F2684}" srcOrd="0" destOrd="0" presId="urn:microsoft.com/office/officeart/2005/8/layout/hProcess6"/>
    <dgm:cxn modelId="{2C0DDB8A-5159-4638-A132-4CCB2119234A}" srcId="{834A4D0A-7B4F-4359-BA93-2C13BF74EDA0}" destId="{5150DBBA-A014-48FD-9CA4-07146E30F64D}" srcOrd="1" destOrd="0" parTransId="{DA971BFC-0D7A-4DE0-BDB8-E0F9EE4474A6}" sibTransId="{43A8421F-1BA2-4BC0-9E74-DC3E843731A4}"/>
    <dgm:cxn modelId="{8FBB7F6C-3DA1-4544-A7CE-9B360E449BC3}" type="presOf" srcId="{1A48361F-612E-432D-B787-BC4DBDD6D90A}" destId="{AAAB698C-F27B-44AE-89C0-200949C3E0BF}" srcOrd="0" destOrd="2" presId="urn:microsoft.com/office/officeart/2005/8/layout/hProcess6"/>
    <dgm:cxn modelId="{79DA2D35-61C3-4266-B00A-6951556BA698}" type="presOf" srcId="{639ED891-5B28-4B29-96A9-A01F716C6E30}" destId="{AAAB698C-F27B-44AE-89C0-200949C3E0BF}" srcOrd="0" destOrd="4" presId="urn:microsoft.com/office/officeart/2005/8/layout/hProcess6"/>
    <dgm:cxn modelId="{057270CE-1920-410A-ABC7-FFDB4359B107}" type="presOf" srcId="{5150DBBA-A014-48FD-9CA4-07146E30F64D}" destId="{DB9C4CDC-829A-4D3A-836C-CB22248CED44}" srcOrd="0" destOrd="0" presId="urn:microsoft.com/office/officeart/2005/8/layout/hProcess6"/>
    <dgm:cxn modelId="{1A5D7740-3AAD-4482-A04A-6AB0B5E690CD}" srcId="{31FBC1D5-391B-444B-B524-94E917D06623}" destId="{639ED891-5B28-4B29-96A9-A01F716C6E30}" srcOrd="4" destOrd="0" parTransId="{487B522A-10CD-49F6-9DF9-19CC13EF4DA4}" sibTransId="{E3D15A27-84A7-4744-901F-D09004205918}"/>
    <dgm:cxn modelId="{389245B5-9E6A-4219-81B9-A7F05015889F}" srcId="{B20DE993-EC76-4012-921D-37ACF96121B2}" destId="{049B07E6-379F-4F93-AAC4-B0B26BC5400D}" srcOrd="4" destOrd="0" parTransId="{3BDA9A0F-164E-4D04-B6ED-C738B0C2D474}" sibTransId="{B1469DC8-BC17-45FF-9EC1-2641FA1A37E8}"/>
    <dgm:cxn modelId="{93862605-53E2-4E04-8421-BF7A7BAAE0F6}" type="presOf" srcId="{049B07E6-379F-4F93-AAC4-B0B26BC5400D}" destId="{FD5FE5AF-D80B-4FBB-9606-C1B3398D8AC2}" srcOrd="0" destOrd="4" presId="urn:microsoft.com/office/officeart/2005/8/layout/hProcess6"/>
    <dgm:cxn modelId="{0BAB58BF-AAA4-46BD-950E-331DF59379AA}" type="presOf" srcId="{A02AE9FF-C39D-4772-9F88-A01CF160D324}" destId="{9D50B4D5-67A0-4F7B-8A36-7FED3A0BADCD}" srcOrd="1" destOrd="2" presId="urn:microsoft.com/office/officeart/2005/8/layout/hProcess6"/>
    <dgm:cxn modelId="{92AAAA8D-0679-45CC-9C72-8FEB8641DC69}" type="presOf" srcId="{E682EC61-8460-43B8-B0F7-1CFBADF7C09A}" destId="{AAAB698C-F27B-44AE-89C0-200949C3E0BF}" srcOrd="0" destOrd="5" presId="urn:microsoft.com/office/officeart/2005/8/layout/hProcess6"/>
    <dgm:cxn modelId="{3EDA1BC9-88F5-4C59-A4C7-65BCB306D230}" type="presOf" srcId="{BE0C1D85-AAFF-420D-BC87-DFFC975AD54E}" destId="{674AF7A1-B4E1-45FE-8271-D9779195F5D9}" srcOrd="1" destOrd="5" presId="urn:microsoft.com/office/officeart/2005/8/layout/hProcess6"/>
    <dgm:cxn modelId="{09C0D18E-65C2-40B2-8183-A0CA08BF25FF}" type="presOf" srcId="{A02AE9FF-C39D-4772-9F88-A01CF160D324}" destId="{DB921617-3D76-43EA-9080-A6928D957AC0}" srcOrd="0" destOrd="2" presId="urn:microsoft.com/office/officeart/2005/8/layout/hProcess6"/>
    <dgm:cxn modelId="{D59C1AFA-7800-46AB-A478-A94120702388}" srcId="{5150DBBA-A014-48FD-9CA4-07146E30F64D}" destId="{A02AE9FF-C39D-4772-9F88-A01CF160D324}" srcOrd="2" destOrd="0" parTransId="{9E19E5C4-913C-401A-9346-85454391A7B6}" sibTransId="{394C0E86-001C-46AD-A45C-8F85901AF628}"/>
    <dgm:cxn modelId="{0F103E32-123E-4871-B8E9-2F834191E013}" type="presOf" srcId="{049B07E6-379F-4F93-AAC4-B0B26BC5400D}" destId="{674AF7A1-B4E1-45FE-8271-D9779195F5D9}" srcOrd="1" destOrd="4" presId="urn:microsoft.com/office/officeart/2005/8/layout/hProcess6"/>
    <dgm:cxn modelId="{D0170951-3004-479B-BA7E-D236F6B32F43}" type="presOf" srcId="{639ED891-5B28-4B29-96A9-A01F716C6E30}" destId="{9F3692B1-8F48-42C6-85DF-6227852D481E}" srcOrd="1" destOrd="4" presId="urn:microsoft.com/office/officeart/2005/8/layout/hProcess6"/>
    <dgm:cxn modelId="{61287FF0-642F-41C2-A4EC-CC17C905F472}" type="presOf" srcId="{07DE7DBE-459C-488B-921C-1798FD60EA0B}" destId="{674AF7A1-B4E1-45FE-8271-D9779195F5D9}" srcOrd="1" destOrd="0" presId="urn:microsoft.com/office/officeart/2005/8/layout/hProcess6"/>
    <dgm:cxn modelId="{8F95FE7F-5699-4A04-9F33-6442F984AE6C}" type="presOf" srcId="{FC8AE758-2B09-4196-8FE9-6F67F6BD2C2D}" destId="{FD5FE5AF-D80B-4FBB-9606-C1B3398D8AC2}" srcOrd="0" destOrd="1" presId="urn:microsoft.com/office/officeart/2005/8/layout/hProcess6"/>
    <dgm:cxn modelId="{14C7BF01-B892-4601-A2C9-91EC9FB33D37}" srcId="{B20DE993-EC76-4012-921D-37ACF96121B2}" destId="{07DE7DBE-459C-488B-921C-1798FD60EA0B}" srcOrd="0" destOrd="0" parTransId="{B1C441C3-C458-41F7-AC39-47F9F3054A17}" sibTransId="{382AB4E6-9B94-47B8-88F7-7FB05D9E6319}"/>
    <dgm:cxn modelId="{EFDA42A5-C303-4D11-8486-F0CF31C364B0}" type="presOf" srcId="{BE0C1D85-AAFF-420D-BC87-DFFC975AD54E}" destId="{FD5FE5AF-D80B-4FBB-9606-C1B3398D8AC2}" srcOrd="0" destOrd="5" presId="urn:microsoft.com/office/officeart/2005/8/layout/hProcess6"/>
    <dgm:cxn modelId="{0B361C4D-EA01-4243-A76F-67E4D254019A}" srcId="{834A4D0A-7B4F-4359-BA93-2C13BF74EDA0}" destId="{31FBC1D5-391B-444B-B524-94E917D06623}" srcOrd="2" destOrd="0" parTransId="{7864CD3C-CE53-4E32-BD2C-4C96558ABF97}" sibTransId="{BB37BEB6-10FF-4092-B45C-1D58BC0E6A57}"/>
    <dgm:cxn modelId="{38A10E6E-4538-4E10-8500-0B21A31E76C6}" srcId="{31FBC1D5-391B-444B-B524-94E917D06623}" destId="{57F6C132-9116-47D5-B649-218BFE557B40}" srcOrd="1" destOrd="0" parTransId="{1713CB1F-2096-465B-BAC3-62CF4F341950}" sibTransId="{58C7C361-799C-4E35-B0AD-6307CD23FA27}"/>
    <dgm:cxn modelId="{CFF64474-B9C5-4A74-8C63-EE5716A427F8}" type="presOf" srcId="{1918FBF4-E643-4F52-92A3-95107699BE21}" destId="{FD5FE5AF-D80B-4FBB-9606-C1B3398D8AC2}" srcOrd="0" destOrd="3" presId="urn:microsoft.com/office/officeart/2005/8/layout/hProcess6"/>
    <dgm:cxn modelId="{93A8FA1D-5D79-4ED6-AD8E-43ADB8893D4B}" srcId="{B20DE993-EC76-4012-921D-37ACF96121B2}" destId="{39955DF2-2E4B-45FB-ADC2-5CAF6E5F4AB0}" srcOrd="7" destOrd="0" parTransId="{B22DEC13-D4A3-43AC-A48D-BB57EF54B77B}" sibTransId="{C88461C2-401D-4217-866A-99764488615D}"/>
    <dgm:cxn modelId="{255EFC92-C096-4371-A3DF-8BEF77452F07}" srcId="{B20DE993-EC76-4012-921D-37ACF96121B2}" destId="{6D276FF8-10B7-4311-AEEA-3660129A06FD}" srcOrd="6" destOrd="0" parTransId="{51891255-A27E-4B4B-94ED-F9BA41CEF62E}" sibTransId="{B9B61D9E-9F60-4FA5-B417-AA6DF1371E9B}"/>
    <dgm:cxn modelId="{3B32DFCF-E29F-4938-862D-F5563BDAFAD0}" srcId="{B20DE993-EC76-4012-921D-37ACF96121B2}" destId="{BE0C1D85-AAFF-420D-BC87-DFFC975AD54E}" srcOrd="5" destOrd="0" parTransId="{C7EAF8A6-3E2B-4BAD-82E1-820E02717236}" sibTransId="{BB49430A-9D19-4C13-8854-5C1A4D9A7CCD}"/>
    <dgm:cxn modelId="{31064EF3-6143-4BA2-846C-E31A1E126CEB}" srcId="{31FBC1D5-391B-444B-B524-94E917D06623}" destId="{7E15A40E-EB63-4F19-9FB6-8BC8EAB63B7A}" srcOrd="0" destOrd="0" parTransId="{E773C87C-F0B9-4922-85D5-B701A31C0C8A}" sibTransId="{EA7471FC-5D26-49CE-95D8-A567D819342F}"/>
    <dgm:cxn modelId="{EC6E18C7-89CE-41CF-9C03-C6ED991CC003}" type="presOf" srcId="{6D276FF8-10B7-4311-AEEA-3660129A06FD}" destId="{674AF7A1-B4E1-45FE-8271-D9779195F5D9}" srcOrd="1" destOrd="6" presId="urn:microsoft.com/office/officeart/2005/8/layout/hProcess6"/>
    <dgm:cxn modelId="{3FB809BD-4872-4A66-BF24-C4E37C57CF1E}" srcId="{31FBC1D5-391B-444B-B524-94E917D06623}" destId="{E682EC61-8460-43B8-B0F7-1CFBADF7C09A}" srcOrd="5" destOrd="0" parTransId="{47BB6492-DF80-489D-9360-A371BB487629}" sibTransId="{6C57644B-2EAE-4579-B72B-27E7FCBF3BF0}"/>
    <dgm:cxn modelId="{098F1E94-24FE-4846-A688-19F42E26615C}" type="presOf" srcId="{834A4D0A-7B4F-4359-BA93-2C13BF74EDA0}" destId="{DDB4539C-42BD-483C-B354-AD3972DB1830}" srcOrd="0" destOrd="0" presId="urn:microsoft.com/office/officeart/2005/8/layout/hProcess6"/>
    <dgm:cxn modelId="{52285C53-D490-4476-BDFC-825228EDAA2F}" srcId="{834A4D0A-7B4F-4359-BA93-2C13BF74EDA0}" destId="{B20DE993-EC76-4012-921D-37ACF96121B2}" srcOrd="0" destOrd="0" parTransId="{840D9F93-76D3-4E61-A557-A3FC019B4CFC}" sibTransId="{13E580C5-B282-40FF-A8D6-DEB9A487222B}"/>
    <dgm:cxn modelId="{6948DE5A-D9A6-4781-AF4D-47225CAD4B6E}" type="presOf" srcId="{184825D8-C33A-42BC-9F24-523D837473BC}" destId="{DB921617-3D76-43EA-9080-A6928D957AC0}" srcOrd="0" destOrd="1" presId="urn:microsoft.com/office/officeart/2005/8/layout/hProcess6"/>
    <dgm:cxn modelId="{140CE37E-098A-4399-8A01-DDCF948B132D}" type="presOf" srcId="{2E4CFC3E-1DC3-431E-9CD7-BE4BF56F5B26}" destId="{DB921617-3D76-43EA-9080-A6928D957AC0}" srcOrd="0" destOrd="0" presId="urn:microsoft.com/office/officeart/2005/8/layout/hProcess6"/>
    <dgm:cxn modelId="{2666A0FA-4349-407E-BA57-7477DBEEAB0D}" type="presOf" srcId="{1A48361F-612E-432D-B787-BC4DBDD6D90A}" destId="{9F3692B1-8F48-42C6-85DF-6227852D481E}" srcOrd="1" destOrd="2" presId="urn:microsoft.com/office/officeart/2005/8/layout/hProcess6"/>
    <dgm:cxn modelId="{04A0110E-BE3F-4587-8677-8C8430FDDCC4}" type="presOf" srcId="{E682EC61-8460-43B8-B0F7-1CFBADF7C09A}" destId="{9F3692B1-8F48-42C6-85DF-6227852D481E}" srcOrd="1" destOrd="5" presId="urn:microsoft.com/office/officeart/2005/8/layout/hProcess6"/>
    <dgm:cxn modelId="{03693CC0-4C0C-48F3-B2CF-166E055BF018}" srcId="{B20DE993-EC76-4012-921D-37ACF96121B2}" destId="{1918FBF4-E643-4F52-92A3-95107699BE21}" srcOrd="3" destOrd="0" parTransId="{C5A08192-E9EF-42BF-9B89-D96BA339ACEB}" sibTransId="{EE8BB1CD-A87B-493D-A76E-230B0391702B}"/>
    <dgm:cxn modelId="{9E493F2B-9610-41AA-8105-588783599362}" srcId="{B20DE993-EC76-4012-921D-37ACF96121B2}" destId="{FC8AE758-2B09-4196-8FE9-6F67F6BD2C2D}" srcOrd="1" destOrd="0" parTransId="{2CAC8BBC-3753-4D45-9B63-E42E51C4A9AE}" sibTransId="{CF129698-BF79-4BED-BAF0-32E041BAAFBB}"/>
    <dgm:cxn modelId="{315BFF21-71D8-4187-8B6B-24E753398151}" srcId="{B20DE993-EC76-4012-921D-37ACF96121B2}" destId="{60107EE6-0C11-4821-B119-F7EC064CF1DC}" srcOrd="2" destOrd="0" parTransId="{38E7ED07-67BF-4AAF-BB68-0D05C78492B0}" sibTransId="{32257F5C-F54E-4462-9767-E9846C0A0B50}"/>
    <dgm:cxn modelId="{58E4C5E2-84B6-4D91-A7F2-5C2258225E12}" srcId="{5150DBBA-A014-48FD-9CA4-07146E30F64D}" destId="{2E4CFC3E-1DC3-431E-9CD7-BE4BF56F5B26}" srcOrd="0" destOrd="0" parTransId="{A7DC3164-4424-48CC-A256-72614D95F963}" sibTransId="{C58881F9-02A4-4A2D-924A-BEF1361E5DCA}"/>
    <dgm:cxn modelId="{9D1D164F-2800-492E-8893-47C32A32405E}" type="presOf" srcId="{6D276FF8-10B7-4311-AEEA-3660129A06FD}" destId="{FD5FE5AF-D80B-4FBB-9606-C1B3398D8AC2}" srcOrd="0" destOrd="6" presId="urn:microsoft.com/office/officeart/2005/8/layout/hProcess6"/>
    <dgm:cxn modelId="{64E01A73-CB25-4CAD-897C-7FD6A30A6BF9}" type="presOf" srcId="{60107EE6-0C11-4821-B119-F7EC064CF1DC}" destId="{674AF7A1-B4E1-45FE-8271-D9779195F5D9}" srcOrd="1" destOrd="2" presId="urn:microsoft.com/office/officeart/2005/8/layout/hProcess6"/>
    <dgm:cxn modelId="{07E38CF1-1363-4680-8D4A-0429E05E5414}" type="presOf" srcId="{57F6C132-9116-47D5-B649-218BFE557B40}" destId="{AAAB698C-F27B-44AE-89C0-200949C3E0BF}" srcOrd="0" destOrd="1" presId="urn:microsoft.com/office/officeart/2005/8/layout/hProcess6"/>
    <dgm:cxn modelId="{EF0B94C6-6735-461E-B518-6D8E6F8CE049}" type="presOf" srcId="{39955DF2-2E4B-45FB-ADC2-5CAF6E5F4AB0}" destId="{674AF7A1-B4E1-45FE-8271-D9779195F5D9}" srcOrd="1" destOrd="7" presId="urn:microsoft.com/office/officeart/2005/8/layout/hProcess6"/>
    <dgm:cxn modelId="{BD9044B5-DD9D-4BBE-A542-96E82BA80783}" type="presOf" srcId="{7E15A40E-EB63-4F19-9FB6-8BC8EAB63B7A}" destId="{9F3692B1-8F48-42C6-85DF-6227852D481E}" srcOrd="1" destOrd="0" presId="urn:microsoft.com/office/officeart/2005/8/layout/hProcess6"/>
    <dgm:cxn modelId="{03895BC7-63F0-4077-8807-AC04D9D98CDD}" type="presOf" srcId="{1918FBF4-E643-4F52-92A3-95107699BE21}" destId="{674AF7A1-B4E1-45FE-8271-D9779195F5D9}" srcOrd="1" destOrd="3" presId="urn:microsoft.com/office/officeart/2005/8/layout/hProcess6"/>
    <dgm:cxn modelId="{B35DFD0F-9A41-4D11-9922-8F4C1F1AD977}" type="presOf" srcId="{2E4CFC3E-1DC3-431E-9CD7-BE4BF56F5B26}" destId="{9D50B4D5-67A0-4F7B-8A36-7FED3A0BADCD}" srcOrd="1" destOrd="0" presId="urn:microsoft.com/office/officeart/2005/8/layout/hProcess6"/>
    <dgm:cxn modelId="{ADC83C59-E7A0-4CCA-8252-AECACA733E10}" type="presOf" srcId="{60107EE6-0C11-4821-B119-F7EC064CF1DC}" destId="{FD5FE5AF-D80B-4FBB-9606-C1B3398D8AC2}" srcOrd="0" destOrd="2" presId="urn:microsoft.com/office/officeart/2005/8/layout/hProcess6"/>
    <dgm:cxn modelId="{BE19C675-912B-41AA-9E0A-8D1F39BDEBD3}" type="presOf" srcId="{07DE7DBE-459C-488B-921C-1798FD60EA0B}" destId="{FD5FE5AF-D80B-4FBB-9606-C1B3398D8AC2}" srcOrd="0" destOrd="0" presId="urn:microsoft.com/office/officeart/2005/8/layout/hProcess6"/>
    <dgm:cxn modelId="{B98F8039-164D-40B2-A87A-C431FC4846EA}" type="presOf" srcId="{39955DF2-2E4B-45FB-ADC2-5CAF6E5F4AB0}" destId="{FD5FE5AF-D80B-4FBB-9606-C1B3398D8AC2}" srcOrd="0" destOrd="7" presId="urn:microsoft.com/office/officeart/2005/8/layout/hProcess6"/>
    <dgm:cxn modelId="{70AD2356-849E-4F40-AFF4-1F0B657B05AB}" type="presOf" srcId="{184825D8-C33A-42BC-9F24-523D837473BC}" destId="{9D50B4D5-67A0-4F7B-8A36-7FED3A0BADCD}" srcOrd="1" destOrd="1" presId="urn:microsoft.com/office/officeart/2005/8/layout/hProcess6"/>
    <dgm:cxn modelId="{B281AD4A-04F7-4000-944B-658B13F66C81}" type="presOf" srcId="{FC8AE758-2B09-4196-8FE9-6F67F6BD2C2D}" destId="{674AF7A1-B4E1-45FE-8271-D9779195F5D9}" srcOrd="1" destOrd="1" presId="urn:microsoft.com/office/officeart/2005/8/layout/hProcess6"/>
    <dgm:cxn modelId="{666E5B3E-9547-4366-900B-AC57838E9B3D}" type="presParOf" srcId="{DDB4539C-42BD-483C-B354-AD3972DB1830}" destId="{D2196A4D-F295-4B49-B2D3-7B36ADB1D0C8}" srcOrd="0" destOrd="0" presId="urn:microsoft.com/office/officeart/2005/8/layout/hProcess6"/>
    <dgm:cxn modelId="{1913CD6F-9FE8-4AAF-B5A5-20C3A6F5E178}" type="presParOf" srcId="{D2196A4D-F295-4B49-B2D3-7B36ADB1D0C8}" destId="{D4DEFC61-50E1-4863-810B-725548DCAEF1}" srcOrd="0" destOrd="0" presId="urn:microsoft.com/office/officeart/2005/8/layout/hProcess6"/>
    <dgm:cxn modelId="{BCF83D20-CBFB-49F2-969E-673037F4131A}" type="presParOf" srcId="{D2196A4D-F295-4B49-B2D3-7B36ADB1D0C8}" destId="{FD5FE5AF-D80B-4FBB-9606-C1B3398D8AC2}" srcOrd="1" destOrd="0" presId="urn:microsoft.com/office/officeart/2005/8/layout/hProcess6"/>
    <dgm:cxn modelId="{771DA313-39FF-4E39-B6E8-874C9AED2D12}" type="presParOf" srcId="{D2196A4D-F295-4B49-B2D3-7B36ADB1D0C8}" destId="{674AF7A1-B4E1-45FE-8271-D9779195F5D9}" srcOrd="2" destOrd="0" presId="urn:microsoft.com/office/officeart/2005/8/layout/hProcess6"/>
    <dgm:cxn modelId="{271715CE-BC07-4DE5-8CF7-0404BEA24100}" type="presParOf" srcId="{D2196A4D-F295-4B49-B2D3-7B36ADB1D0C8}" destId="{AE8C43CD-72A9-4611-AAA1-7A65254F2684}" srcOrd="3" destOrd="0" presId="urn:microsoft.com/office/officeart/2005/8/layout/hProcess6"/>
    <dgm:cxn modelId="{83654137-7885-4634-AE4F-C4009090F009}" type="presParOf" srcId="{DDB4539C-42BD-483C-B354-AD3972DB1830}" destId="{B2582866-5DCA-496D-9BCF-C16385E842E5}" srcOrd="1" destOrd="0" presId="urn:microsoft.com/office/officeart/2005/8/layout/hProcess6"/>
    <dgm:cxn modelId="{45FD0D8B-211F-4953-9AD0-F9391C68DCD8}" type="presParOf" srcId="{DDB4539C-42BD-483C-B354-AD3972DB1830}" destId="{59E6896B-4A7C-4074-857B-45A9D4F0F68A}" srcOrd="2" destOrd="0" presId="urn:microsoft.com/office/officeart/2005/8/layout/hProcess6"/>
    <dgm:cxn modelId="{83CE2760-91B6-48EF-9727-FFF129096B59}" type="presParOf" srcId="{59E6896B-4A7C-4074-857B-45A9D4F0F68A}" destId="{08FA1EAD-C649-432A-8CA4-5A04CA1B0426}" srcOrd="0" destOrd="0" presId="urn:microsoft.com/office/officeart/2005/8/layout/hProcess6"/>
    <dgm:cxn modelId="{B2595B14-4420-4408-99EE-77CD113A74D2}" type="presParOf" srcId="{59E6896B-4A7C-4074-857B-45A9D4F0F68A}" destId="{DB921617-3D76-43EA-9080-A6928D957AC0}" srcOrd="1" destOrd="0" presId="urn:microsoft.com/office/officeart/2005/8/layout/hProcess6"/>
    <dgm:cxn modelId="{E45078C0-1978-4CFB-9CC2-A06A8545CC3E}" type="presParOf" srcId="{59E6896B-4A7C-4074-857B-45A9D4F0F68A}" destId="{9D50B4D5-67A0-4F7B-8A36-7FED3A0BADCD}" srcOrd="2" destOrd="0" presId="urn:microsoft.com/office/officeart/2005/8/layout/hProcess6"/>
    <dgm:cxn modelId="{2AA5865F-739D-41DC-8B39-49C2E1539B9B}" type="presParOf" srcId="{59E6896B-4A7C-4074-857B-45A9D4F0F68A}" destId="{DB9C4CDC-829A-4D3A-836C-CB22248CED44}" srcOrd="3" destOrd="0" presId="urn:microsoft.com/office/officeart/2005/8/layout/hProcess6"/>
    <dgm:cxn modelId="{A80451A3-BE38-4DD4-9271-0F3019864510}" type="presParOf" srcId="{DDB4539C-42BD-483C-B354-AD3972DB1830}" destId="{A33C1EFC-4304-4BE8-9838-50B03682242F}" srcOrd="3" destOrd="0" presId="urn:microsoft.com/office/officeart/2005/8/layout/hProcess6"/>
    <dgm:cxn modelId="{78F1D744-733E-44A2-B7E2-86817C0F25C4}" type="presParOf" srcId="{DDB4539C-42BD-483C-B354-AD3972DB1830}" destId="{10A02346-F88F-43BF-89F9-F2E597165644}" srcOrd="4" destOrd="0" presId="urn:microsoft.com/office/officeart/2005/8/layout/hProcess6"/>
    <dgm:cxn modelId="{2B9A9F55-3222-4874-BD90-3504CD56671F}" type="presParOf" srcId="{10A02346-F88F-43BF-89F9-F2E597165644}" destId="{FC1DD737-B969-4F9D-9752-AA1BCF340654}" srcOrd="0" destOrd="0" presId="urn:microsoft.com/office/officeart/2005/8/layout/hProcess6"/>
    <dgm:cxn modelId="{BA661BA7-6E12-4E3D-87B3-ED0587FE4C35}" type="presParOf" srcId="{10A02346-F88F-43BF-89F9-F2E597165644}" destId="{AAAB698C-F27B-44AE-89C0-200949C3E0BF}" srcOrd="1" destOrd="0" presId="urn:microsoft.com/office/officeart/2005/8/layout/hProcess6"/>
    <dgm:cxn modelId="{530C6E9D-E204-4042-BFE9-7B772D8A40A4}" type="presParOf" srcId="{10A02346-F88F-43BF-89F9-F2E597165644}" destId="{9F3692B1-8F48-42C6-85DF-6227852D481E}" srcOrd="2" destOrd="0" presId="urn:microsoft.com/office/officeart/2005/8/layout/hProcess6"/>
    <dgm:cxn modelId="{5F1C4955-473F-4706-82C7-C8E01B25C1E3}" type="presParOf" srcId="{10A02346-F88F-43BF-89F9-F2E597165644}" destId="{651066C6-62ED-4D8C-AE28-B19E8DDBBC20}" srcOrd="3" destOrd="0" presId="urn:microsoft.com/office/officeart/2005/8/layout/hProcess6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5FE5AF-D80B-4FBB-9606-C1B3398D8AC2}">
      <dsp:nvSpPr>
        <dsp:cNvPr id="0" name=""/>
        <dsp:cNvSpPr/>
      </dsp:nvSpPr>
      <dsp:spPr>
        <a:xfrm>
          <a:off x="661760" y="2197648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400" tIns="6350" rIns="12700" bIns="6350" numCol="1" spcCol="1270" anchor="ctr" anchorCtr="0">
          <a:noAutofit/>
        </a:bodyPr>
        <a:lstStyle/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Cholesterol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Blood pressure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Smoking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Weight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Height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Web app ?s on Socio-Demographics and Medication Adherence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000" kern="1200" dirty="0"/>
        </a:p>
      </dsp:txBody>
      <dsp:txXfrm>
        <a:off x="1318544" y="2542115"/>
        <a:ext cx="1280729" cy="1607515"/>
      </dsp:txXfrm>
    </dsp:sp>
    <dsp:sp modelId="{AE8C43CD-72A9-4611-AAA1-7A65254F2684}">
      <dsp:nvSpPr>
        <dsp:cNvPr id="0" name=""/>
        <dsp:cNvSpPr/>
      </dsp:nvSpPr>
      <dsp:spPr>
        <a:xfrm>
          <a:off x="4975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Baseline clinical </a:t>
          </a:r>
          <a:r>
            <a:rPr lang="en-GB" sz="1500" kern="1200" dirty="0"/>
            <a:t>visit</a:t>
          </a:r>
        </a:p>
      </dsp:txBody>
      <dsp:txXfrm>
        <a:off x="197343" y="2881456"/>
        <a:ext cx="928832" cy="928832"/>
      </dsp:txXfrm>
    </dsp:sp>
    <dsp:sp modelId="{DB921617-3D76-43EA-9080-A6928D957AC0}">
      <dsp:nvSpPr>
        <dsp:cNvPr id="0" name=""/>
        <dsp:cNvSpPr/>
      </dsp:nvSpPr>
      <dsp:spPr>
        <a:xfrm>
          <a:off x="4109878" y="2197648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400" tIns="6350" rIns="12700" bIns="6350" numCol="1" spcCol="1270" anchor="ctr" anchorCtr="0">
          <a:noAutofit/>
        </a:bodyPr>
        <a:lstStyle/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12 week Cholesterol </a:t>
          </a:r>
          <a:r>
            <a:rPr lang="en-GB" sz="1000" kern="1200" dirty="0" err="1" smtClean="0"/>
            <a:t>CarePlan</a:t>
          </a:r>
          <a:r>
            <a:rPr lang="en-GB" sz="1000" kern="1200" dirty="0" smtClean="0"/>
            <a:t> ?s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smtClean="0"/>
            <a:t>Additional </a:t>
          </a:r>
          <a:r>
            <a:rPr lang="en-GB" sz="1000" kern="1200" smtClean="0"/>
            <a:t>Web </a:t>
          </a:r>
          <a:r>
            <a:rPr lang="en-GB" sz="1000" kern="1200" dirty="0" smtClean="0"/>
            <a:t>app ?s at weeks 1, 6, 12 &amp; 24.</a:t>
          </a:r>
          <a:endParaRPr lang="en-GB" sz="1000" kern="1200" dirty="0"/>
        </a:p>
      </dsp:txBody>
      <dsp:txXfrm>
        <a:off x="4766663" y="2542115"/>
        <a:ext cx="1280729" cy="1607515"/>
      </dsp:txXfrm>
    </dsp:sp>
    <dsp:sp modelId="{DB9C4CDC-829A-4D3A-836C-CB22248CED44}">
      <dsp:nvSpPr>
        <dsp:cNvPr id="0" name=""/>
        <dsp:cNvSpPr/>
      </dsp:nvSpPr>
      <dsp:spPr>
        <a:xfrm>
          <a:off x="3453094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24 weeks</a:t>
          </a:r>
          <a:endParaRPr lang="en-GB" sz="1500" kern="1200" dirty="0"/>
        </a:p>
      </dsp:txBody>
      <dsp:txXfrm>
        <a:off x="3645462" y="2881456"/>
        <a:ext cx="928832" cy="928832"/>
      </dsp:txXfrm>
    </dsp:sp>
    <dsp:sp modelId="{AAAB698C-F27B-44AE-89C0-200949C3E0BF}">
      <dsp:nvSpPr>
        <dsp:cNvPr id="0" name=""/>
        <dsp:cNvSpPr/>
      </dsp:nvSpPr>
      <dsp:spPr>
        <a:xfrm>
          <a:off x="7562962" y="2178036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400" tIns="6350" rIns="12700" bIns="6350" numCol="1" spcCol="1270" anchor="ctr" anchorCtr="0">
          <a:noAutofit/>
        </a:bodyPr>
        <a:lstStyle/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Cholesterol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smtClean="0"/>
            <a:t>Blood pressure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Smoking</a:t>
          </a:r>
          <a:endParaRPr lang="en-GB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Weight</a:t>
          </a:r>
          <a:endParaRPr lang="en-US" sz="1000" kern="1200" dirty="0"/>
        </a:p>
        <a:p>
          <a:pPr marL="57150" lvl="1" indent="-57150" algn="l" defTabSz="4445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000" kern="1200" dirty="0" smtClean="0"/>
            <a:t>Web app ?s on Medication Adherence</a:t>
          </a:r>
          <a:endParaRPr lang="en-US" sz="1000" kern="1200" dirty="0"/>
        </a:p>
      </dsp:txBody>
      <dsp:txXfrm>
        <a:off x="8219747" y="2522503"/>
        <a:ext cx="1280729" cy="1607515"/>
      </dsp:txXfrm>
    </dsp:sp>
    <dsp:sp modelId="{651066C6-62ED-4D8C-AE28-B19E8DDBBC20}">
      <dsp:nvSpPr>
        <dsp:cNvPr id="0" name=""/>
        <dsp:cNvSpPr/>
      </dsp:nvSpPr>
      <dsp:spPr>
        <a:xfrm>
          <a:off x="6901212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/>
            <a:t>Follow up clinical </a:t>
          </a:r>
          <a:r>
            <a:rPr lang="en-GB" sz="1500" kern="1200" dirty="0" smtClean="0"/>
            <a:t>visits at 12 &amp; 24 weeks</a:t>
          </a:r>
          <a:endParaRPr lang="en-GB" sz="1500" kern="1200" dirty="0"/>
        </a:p>
      </dsp:txBody>
      <dsp:txXfrm>
        <a:off x="7093580" y="2881456"/>
        <a:ext cx="928832" cy="92883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6">
  <dgm:title val=""/>
  <dgm:desc val=""/>
  <dgm:catLst>
    <dgm:cat type="process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  <dgm:cxn modelId="33" srcId="3" destId="31" srcOrd="0" destOrd="0"/>
        <dgm:cxn modelId="34" srcId="3" destId="32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theList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L"/>
          <dgm:param type="nodeHorzAlign" val="l"/>
        </dgm:alg>
      </dgm:if>
      <dgm:else name="Name2">
        <dgm:alg type="lin">
          <dgm:param type="linDir" val="from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h" for="ch" forName="compNode" refType="w" refFor="ch" refForName="compNode" fact="0.7"/>
      <dgm:constr type="ctrY" for="ch" forName="compNode" refType="h" fact="0.5"/>
      <dgm:constr type="w" for="ch" forName="aSpace" refType="w" fact="0.05"/>
      <dgm:constr type="primFontSz" for="des" forName="childTextHidden" op="equ" val="65"/>
      <dgm:constr type="primFontSz" for="des" forName="parentText" op="equ"/>
    </dgm:constrLst>
    <dgm:ruleLst/>
    <dgm:forEach name="aNodeForEach" axis="ch" ptType="node">
      <dgm:layoutNode name="compNode">
        <dgm:alg type="composite">
          <dgm:param type="ar" val="1.43"/>
        </dgm:alg>
        <dgm:shape xmlns:r="http://schemas.openxmlformats.org/officeDocument/2006/relationships" r:blip="">
          <dgm:adjLst/>
        </dgm:shape>
        <dgm:presOf/>
        <dgm:choose name="Name3">
          <dgm:if name="Name4" func="var" arg="dir" op="equ" val="norm">
            <dgm:constrLst>
              <dgm:constr type="w" for="ch" forName="childTextVisible" refType="w" fact="0.8"/>
              <dgm:constr type="h" for="ch" forName="childTextVisible" refType="h"/>
              <dgm:constr type="r" for="ch" forName="childTextVisible" refType="w"/>
              <dgm:constr type="w" for="ch" forName="childTextHidden" refType="w" fact="0.6"/>
              <dgm:constr type="h" for="ch" forName="childTextHidden" refType="h"/>
              <dgm:constr type="r" for="ch" forName="childTextHidden" refType="w"/>
              <dgm:constr type="l" for="ch" forName="parentText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if>
          <dgm:else name="Name5">
            <dgm:constrLst>
              <dgm:constr type="w" for="ch" forName="childTextVisible" refType="w" fact="0.8"/>
              <dgm:constr type="h" for="ch" forName="childTextVisible" refType="h"/>
              <dgm:constr type="l" for="ch" forName="childTextVisible"/>
              <dgm:constr type="w" for="ch" forName="childTextHidden" refType="w" fact="0.6"/>
              <dgm:constr type="h" for="ch" forName="childTextHidden" refType="h"/>
              <dgm:constr type="l" for="ch" forName="childTextHidden"/>
              <dgm:constr type="r" for="ch" forName="parentText" refType="w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else>
        </dgm:choose>
        <dgm:ruleLst/>
        <dgm:layoutNode name="noGeometry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childTextVisible" styleLbl="bgAccFollowNode1">
          <dgm:varLst>
            <dgm:bulletEnabled val="1"/>
          </dgm:varLst>
          <dgm:alg type="sp"/>
          <dgm:choose name="Name6">
            <dgm:if name="Name7" func="var" arg="dir" op="equ" val="norm">
              <dgm:shape xmlns:r="http://schemas.openxmlformats.org/officeDocument/2006/relationships" type="rightArrow" r:blip="">
                <dgm:adjLst>
                  <dgm:adj idx="1" val="0.7"/>
                  <dgm:adj idx="2" val="0.5"/>
                </dgm:adjLst>
              </dgm:shape>
            </dgm:if>
            <dgm:else name="Name8">
              <dgm:shape xmlns:r="http://schemas.openxmlformats.org/officeDocument/2006/relationships" type="leftArrow" r:blip="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/>
          <dgm:ruleLst/>
        </dgm:layoutNode>
        <dgm:layoutNode name="childTextHidden" styleLbl="bgAccFollowNode1">
          <dgm:choose name="Name9">
            <dgm:if name="Name10" axis="des followSib" ptType="node node" st="1 1" cnt="1 0" func="cnt" op="gte" val="1">
              <dgm:alg type="tx">
                <dgm:param type="stBulletLvl" val="1"/>
                <dgm:param type="txAnchorVertCh" val="mid"/>
              </dgm:alg>
            </dgm:if>
            <dgm:else name="Name11">
              <dgm:alg type="tx">
                <dgm:param type="stBulletLvl" val="2"/>
                <dgm:param type="txAnchorVertCh" val="mid"/>
              </dgm:alg>
            </dgm:else>
          </dgm:choose>
          <dgm:choose name="Name12">
            <dgm:if name="Name13" func="var" arg="dir" op="equ" val="norm">
              <dgm:shape xmlns:r="http://schemas.openxmlformats.org/officeDocument/2006/relationships" type="rightArrow" r:blip="" hideGeom="1">
                <dgm:adjLst>
                  <dgm:adj idx="1" val="0.7"/>
                  <dgm:adj idx="2" val="0.5"/>
                </dgm:adjLst>
              </dgm:shape>
            </dgm:if>
            <dgm:else name="Name14">
              <dgm:shape xmlns:r="http://schemas.openxmlformats.org/officeDocument/2006/relationships" type="leftArrow" r:blip="" hideGeom="1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rMarg" refType="primFontSz" fact="0.1"/>
            <dgm:constr type="lMarg" refType="primFontSz" fact="0.2"/>
          </dgm:constrLst>
          <dgm:ruleLst>
            <dgm:rule type="primFontSz" val="5" fact="NaN" max="NaN"/>
          </dgm:ruleLst>
        </dgm:layoutNode>
        <dgm:layoutNode name="parentText" styleLbl="node1">
          <dgm:varLst>
            <dgm:chMax val="1"/>
            <dgm:bulletEnabled val="1"/>
          </dgm:varLst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primFontSz" val="65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choose name="Name15">
        <dgm:if name="Name16" axis="self" ptType="node" func="revPos" op="gte" val="2">
          <dgm:layoutNode name="a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if>
        <dgm:else name="Name17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1238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2820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3693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087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272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7396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2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679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964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788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342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0BCF5-97CC-4A98-9415-337F09336794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E8254-6112-4933-B929-33CE4708CA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0428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 2"/>
          <p:cNvGraphicFramePr/>
          <p:nvPr>
            <p:extLst>
              <p:ext uri="{D42A27DB-BD31-4B8C-83A1-F6EECF244321}">
                <p14:modId xmlns:p14="http://schemas.microsoft.com/office/powerpoint/2010/main" val="1892218233"/>
              </p:ext>
            </p:extLst>
          </p:nvPr>
        </p:nvGraphicFramePr>
        <p:xfrm>
          <a:off x="408616" y="436419"/>
          <a:ext cx="10190111" cy="66917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56CE12ED-08F6-4707-A979-BF08D41E0406}"/>
              </a:ext>
            </a:extLst>
          </p:cNvPr>
          <p:cNvSpPr txBox="1"/>
          <p:nvPr/>
        </p:nvSpPr>
        <p:spPr>
          <a:xfrm>
            <a:off x="557048" y="1123693"/>
            <a:ext cx="2963918" cy="1200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1. During baseline visit, patient </a:t>
            </a:r>
            <a:r>
              <a:rPr lang="en-GB" sz="1400" dirty="0"/>
              <a:t>consents to research </a:t>
            </a:r>
            <a:r>
              <a:rPr lang="en-GB" sz="1400" dirty="0" smtClean="0"/>
              <a:t>and is clinically assessed. </a:t>
            </a:r>
            <a:r>
              <a:rPr lang="en-GB" sz="1400" dirty="0"/>
              <a:t>Patient </a:t>
            </a:r>
            <a:r>
              <a:rPr lang="en-GB" sz="1400" dirty="0" smtClean="0"/>
              <a:t>logs </a:t>
            </a:r>
            <a:r>
              <a:rPr lang="en-GB" sz="1400" dirty="0"/>
              <a:t>into the </a:t>
            </a:r>
            <a:r>
              <a:rPr lang="en-GB" sz="1400" dirty="0"/>
              <a:t>W</a:t>
            </a:r>
            <a:r>
              <a:rPr lang="en-GB" sz="1400" dirty="0" smtClean="0"/>
              <a:t>eb </a:t>
            </a:r>
            <a:r>
              <a:rPr lang="en-GB" sz="1400" dirty="0" smtClean="0"/>
              <a:t>app </a:t>
            </a:r>
            <a:r>
              <a:rPr lang="en-GB" sz="1400" dirty="0"/>
              <a:t>via smartphone and </a:t>
            </a:r>
            <a:r>
              <a:rPr lang="en-GB" sz="1400" dirty="0" smtClean="0"/>
              <a:t>answers ?s.</a:t>
            </a:r>
            <a:endParaRPr lang="en-GB" sz="1400" dirty="0"/>
          </a:p>
          <a:p>
            <a:endParaRPr lang="en-GB" sz="16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A8D5F7A-5F8A-4301-8808-BA4FAE553224}"/>
              </a:ext>
            </a:extLst>
          </p:cNvPr>
          <p:cNvSpPr txBox="1"/>
          <p:nvPr/>
        </p:nvSpPr>
        <p:spPr>
          <a:xfrm>
            <a:off x="3888828" y="1159166"/>
            <a:ext cx="3142593" cy="9541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2. In their own time, </a:t>
            </a:r>
            <a:r>
              <a:rPr lang="en-GB" sz="1400" dirty="0"/>
              <a:t>p</a:t>
            </a:r>
            <a:r>
              <a:rPr lang="en-GB" sz="1400" dirty="0" smtClean="0"/>
              <a:t>atient </a:t>
            </a:r>
            <a:r>
              <a:rPr lang="en-GB" sz="1400" dirty="0"/>
              <a:t>is sent text reminders </a:t>
            </a:r>
            <a:r>
              <a:rPr lang="en-GB" sz="1400" dirty="0" smtClean="0"/>
              <a:t>to respond to weekly </a:t>
            </a:r>
            <a:r>
              <a:rPr lang="en-GB" sz="1400" dirty="0" smtClean="0"/>
              <a:t>Web </a:t>
            </a:r>
            <a:r>
              <a:rPr lang="en-GB" sz="1400" dirty="0" smtClean="0"/>
              <a:t>app </a:t>
            </a:r>
            <a:r>
              <a:rPr lang="en-GB" sz="1400" dirty="0" smtClean="0"/>
              <a:t>?s </a:t>
            </a:r>
            <a:r>
              <a:rPr lang="en-GB" sz="1400" dirty="0" smtClean="0"/>
              <a:t>and to book follow up visits.</a:t>
            </a:r>
            <a:endParaRPr lang="en-GB" sz="1400" dirty="0"/>
          </a:p>
          <a:p>
            <a:endParaRPr lang="en-GB" sz="1400" dirty="0" smtClean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30AB396-35D5-48BA-84A1-F81A8E6C4658}"/>
              </a:ext>
            </a:extLst>
          </p:cNvPr>
          <p:cNvSpPr txBox="1"/>
          <p:nvPr/>
        </p:nvSpPr>
        <p:spPr>
          <a:xfrm>
            <a:off x="7378262" y="1141629"/>
            <a:ext cx="3220465" cy="9541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3. During the follow up visit, patient is clinically assessed</a:t>
            </a:r>
            <a:r>
              <a:rPr lang="en-GB" sz="1400" dirty="0"/>
              <a:t> </a:t>
            </a:r>
            <a:r>
              <a:rPr lang="en-GB" sz="1400" dirty="0" smtClean="0"/>
              <a:t>and answers questions on the </a:t>
            </a:r>
            <a:r>
              <a:rPr lang="en-GB" sz="1400" dirty="0" smtClean="0"/>
              <a:t>Web </a:t>
            </a:r>
            <a:r>
              <a:rPr lang="en-GB" sz="1400" dirty="0" smtClean="0"/>
              <a:t>app using their smartphone.</a:t>
            </a:r>
          </a:p>
          <a:p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4007704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4</TotalTime>
  <Words>14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rmayat, Kanika S</dc:creator>
  <cp:lastModifiedBy>Woringer, Maria</cp:lastModifiedBy>
  <cp:revision>94</cp:revision>
  <dcterms:created xsi:type="dcterms:W3CDTF">2017-10-18T10:10:21Z</dcterms:created>
  <dcterms:modified xsi:type="dcterms:W3CDTF">2018-11-19T12:56:36Z</dcterms:modified>
</cp:coreProperties>
</file>